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56" r:id="rId3"/>
    <p:sldId id="257" r:id="rId4"/>
    <p:sldId id="258" r:id="rId5"/>
    <p:sldId id="259" r:id="rId6"/>
    <p:sldId id="260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4"/>
    <p:restoredTop sz="94719"/>
  </p:normalViewPr>
  <p:slideViewPr>
    <p:cSldViewPr snapToGrid="0">
      <p:cViewPr varScale="1">
        <p:scale>
          <a:sx n="106" d="100"/>
          <a:sy n="106" d="100"/>
        </p:scale>
        <p:origin x="696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4937DF-92EE-534A-9FFD-F747780F37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B2D70A-22F6-E1B0-3C4E-72CE3A65B6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F30D39-A120-A47A-B3F3-93EEB4556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D9FC2E-7152-7AD9-19C5-DEB19EF8F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9090F-C59C-ABD9-4C81-0855E1515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4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294F9D-FD35-E161-5206-D801A48AF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3C950C-A2A8-F6AD-04F8-1892138C53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CCDF14-04A6-5D61-32A6-CDC1BED6D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220237-AA10-B032-7AE5-C31F3F0E0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7A5916-3AD8-91EA-BEE0-93058D5A4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224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A978CF-A54D-2359-81D0-682BA9B4B8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FE46AC-73DF-1B41-F81B-CE19E93C1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ED493A-8EE3-C350-FF19-7A20E13FA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56B845-B924-F2BC-3471-652E50D2F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D8228A-61BF-7E62-6865-44F7C185D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508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35FAD1-0DEE-E944-0D12-F4123B2231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FD36D3-E636-9A71-D324-0F26ABCDA0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6014A-AB04-DFEB-F83D-91C130187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27BC55-16DF-89A9-1986-6B7610ECB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BAF82B-DEFA-338C-6AFD-17A494095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975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0F64AD-26D7-CBDC-E8AE-30B842F6A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58B8DC-B6F2-19B8-1046-A207E2A09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E54B-7043-3915-4639-BBB1016EE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3D5F24-EC44-5E9B-DC5B-47BFB3A67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E98BF7-5935-6A6B-A62E-729197042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67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5A9313-FB43-5795-7895-08923531D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D46567-966A-4556-4FC6-7BF0A15E15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364BFB-8909-3A6C-D42F-D79A807223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81CC2-5AC1-65E8-AA84-8F4CC6463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BCEAA7-D9C2-0820-BDC2-FC0C2C844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0DD6B1-1B1E-D6EC-6869-6BC040C2D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01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14CB9-AF02-5D5D-D75C-C63668ECC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873516-487B-FF71-4EEA-241184F772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D99356-1D86-7162-C515-B58B3D2D19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095884-F3AD-27D4-7949-BBBA228E61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7C1717-8A40-1277-6F23-585B3A3568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D4B1CC-7AA2-BCC8-079E-881FC79CF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76AADB-C1D3-7DB1-7560-6548B4113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A80CA3-CA88-EC16-0DDA-5BEFE0754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431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A3BD0-20C8-67D2-BE82-DD102ED95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BDD739-2753-E102-FE30-97879D524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70CF79-3C6D-7775-6693-63DDD8442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506E41-EE27-35A3-0E20-148A8538A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186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A834E1-AE38-6B9E-566A-B571C0A84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3E4F8E-7756-6DA6-CC9F-34DEDDFF6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3B203A-95A4-9510-E143-98DF97492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040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70E3E6-6AFC-B98E-0E05-C0C8F8D778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619980-3683-00FA-4174-54393615B1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F79ADB-C90A-64B2-354A-1AB97E5ED9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B4C45D-D101-F529-1B71-ACA42A11B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2F26CD-2140-739C-2DD1-A69A1D657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905B32-2AA2-6155-558B-72583DDB3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375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3953C-A28D-57AA-8C54-8186787AE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AA8F820-6E26-F37B-0F2D-8E56F84761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0D42E8-429A-0DE0-5A07-2CFA977561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59950D-41E1-2FE2-4B5A-A4F1AF0AD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B8D2BC-8B88-C5CC-E74B-5C48FF10F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AD6B90-4115-88ED-E8A6-CBAC2D9A2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622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2CE6AE-952D-EE22-C28B-7EC6E9B2C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973CE3-D31C-4066-9E84-A18FB3077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E48D9A-26E8-E253-C93F-DD1A6BA3A3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A12084-F018-E141-BB86-FC65E5C16142}" type="datetimeFigureOut">
              <a:rPr lang="en-US" smtClean="0"/>
              <a:t>8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CE684-08A9-16EA-93A5-4665496060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D0328B-A112-9FEB-C17D-4AEA2EF0FA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1F09AD-5983-AF44-91CA-49864667D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6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C86C328-825D-2639-2B34-7ECE7D3FB084}"/>
              </a:ext>
            </a:extLst>
          </p:cNvPr>
          <p:cNvSpPr txBox="1"/>
          <p:nvPr/>
        </p:nvSpPr>
        <p:spPr>
          <a:xfrm>
            <a:off x="288758" y="168443"/>
            <a:ext cx="11754853" cy="1901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6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1 :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 </a:t>
            </a:r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chematic representation of </a:t>
            </a:r>
            <a:r>
              <a:rPr lang="en-GB" sz="1600" b="1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RBA</a:t>
            </a:r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variants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dentified in  our cohort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The numbers preceding each mutation correspond to the patient number in our series. Each symbol represents a specific domain or region: N: N amino terminus; C: Carboxyl terminus; ConA: Concavalin A or Lam G, associated with protein trafficking; DUF: Domain of Unknown Function; WD40 ; PH: Pleckstrin homology domain; BEACH: Beige and Chediak-Higashi domain. The red colour highlights the patients harbouring compound heterozygous mutations and black represents homozygous state. Mutations highlighted in bold are novel mutations.</a:t>
            </a:r>
            <a:endParaRPr lang="en-IN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A diagram of a computer program&#10;&#10;AI-generated content may be incorrect.">
            <a:extLst>
              <a:ext uri="{FF2B5EF4-FFF2-40B4-BE49-F238E27FC236}">
                <a16:creationId xmlns:a16="http://schemas.microsoft.com/office/drawing/2014/main" id="{64151CDB-098B-15A8-AC13-472091BE04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4107" y="1979351"/>
            <a:ext cx="8398042" cy="47102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1126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E005677-67BE-5AAD-1143-1132DC0C1223}"/>
              </a:ext>
            </a:extLst>
          </p:cNvPr>
          <p:cNvSpPr txBox="1"/>
          <p:nvPr/>
        </p:nvSpPr>
        <p:spPr>
          <a:xfrm>
            <a:off x="90236" y="279519"/>
            <a:ext cx="12101764" cy="793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6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2 : </a:t>
            </a:r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chematic representation of </a:t>
            </a:r>
            <a:r>
              <a:rPr lang="en-GB" sz="1600" b="1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TLA4</a:t>
            </a:r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variants identified in our cohort.  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 numbers preceding each mutation correspond to the patient number in our series Mutations highlighted in bold are novel mutations.</a:t>
            </a:r>
            <a:endParaRPr lang="en-IN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diagram of a dna structure&#10;&#10;AI-generated content may be incorrect.">
            <a:extLst>
              <a:ext uri="{FF2B5EF4-FFF2-40B4-BE49-F238E27FC236}">
                <a16:creationId xmlns:a16="http://schemas.microsoft.com/office/drawing/2014/main" id="{573840F6-4BD4-25E1-79FA-F08D844E8D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1442" y="1325733"/>
            <a:ext cx="9071810" cy="508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38531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D9630FF-D963-3975-8430-6B5543F2895B}"/>
              </a:ext>
            </a:extLst>
          </p:cNvPr>
          <p:cNvSpPr txBox="1"/>
          <p:nvPr/>
        </p:nvSpPr>
        <p:spPr>
          <a:xfrm>
            <a:off x="150394" y="0"/>
            <a:ext cx="12041605" cy="2658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3: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tepwise gating strategy for lymphocyte subset analysis.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FSC-H vs. FSC-A plot was used to remove doublets and cell debris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B) 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SC-A vs. CD45 was used to gate lymphocytes, based on low forward/side scatter and bright CD45 expression. (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T cells were gated using CD45 and CD3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D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h (T helper ) and Tc (Cytotoxic T cells) were identified using CD4 and CD8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E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o distinguish between </a:t>
            </a:r>
            <a:r>
              <a:rPr lang="en-IN" sz="14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γδ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αβ T cells, TCRγδ staining was employed. Cells positive for TCRγδ were classified as </a:t>
            </a:r>
            <a:r>
              <a:rPr lang="en-IN" sz="14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γδ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 cells; those that were TCRγδ-negative were assumed to be αβ T cells.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F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Within the TCRγδ-negative population (i.e., αβ T cells), double-negative T cells were defined as CD3⁺ CD4⁻ CD8⁻ TCRγδ⁻ cells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(G,H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d on varied expression of CD45RA and CD27 Th/Tc memory populations were distinguished as naïve (CD45RA+CD27+), central memory(CD45RA-CD27+), effector memory (CD45RA-CD27-) and TEMRA (CD45RA+CD27-). (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Density plot demonstrating NK (Natural killer) cells (CD3- CD16/CD56+) and NKT (Natural killer T) cells (CD3+ CD16/CD56+).(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J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B cells were gated as CD19+CD3-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(K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 B cell subpopulations were further identified using expression of CD27. CD19+CD27+ population were identified as Memory B cells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(L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n those memory B cells, IgD-IgM- population was identified as Class switched memory B cells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 names written above the plot [name] represent the parent gate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group of images of a diagram&#10;&#10;AI-generated content may be incorrect.">
            <a:extLst>
              <a:ext uri="{FF2B5EF4-FFF2-40B4-BE49-F238E27FC236}">
                <a16:creationId xmlns:a16="http://schemas.microsoft.com/office/drawing/2014/main" id="{934DA48C-A96D-45F5-4971-78D0F5BBE6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959" y="2822510"/>
            <a:ext cx="10431378" cy="3779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7425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60ABB64-29A8-EC37-7D25-3783C7831D8F}"/>
              </a:ext>
            </a:extLst>
          </p:cNvPr>
          <p:cNvSpPr txBox="1"/>
          <p:nvPr/>
        </p:nvSpPr>
        <p:spPr>
          <a:xfrm>
            <a:off x="0" y="0"/>
            <a:ext cx="12192000" cy="20178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4 :  Gating strategy for B cell immunophenotyping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800"/>
              </a:spcAft>
              <a:buFont typeface="+mj-lt"/>
              <a:buAutoNum type="alphaUcParenBoth"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SC-H vs. FSC-A plot was used to remove doublets and cell debris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B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SC-A versus FSC-A was used to identify MNCS (Mononuclear cells), which are predominately lymphocytes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C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n these MNC’s B cells were identified using SSC-A and CD19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D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ased on expression of CD27, B cells were identified as memory B cells (CD19+CD27+) .(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) 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lasmablasts (CD19+CD27+IgD-CD38++) were identified on these cells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F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lass switched memory B cells (CD19+CD27+IgD-IgM-) were also identified. 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G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D21 low B cells (CD19+CD38-CD21-) cells were identified on total B cells</a:t>
            </a:r>
            <a:r>
              <a:rPr lang="en-IN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(H,I)</a:t>
            </a: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or transitional B cells (CD19+CD24+CD10+CD38+), CD24 was used as marker on B cells and further identified as transitional B cells based on expression of CD10 and CD38. 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228600"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 names written above the plot [name] represent the parent gate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diagram of a diagram of a cell&#10;&#10;AI-generated content may be incorrect.">
            <a:extLst>
              <a:ext uri="{FF2B5EF4-FFF2-40B4-BE49-F238E27FC236}">
                <a16:creationId xmlns:a16="http://schemas.microsoft.com/office/drawing/2014/main" id="{09E993F1-A4EE-2CB9-A381-88B197D84A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4421" y="2017860"/>
            <a:ext cx="9192125" cy="4728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14567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2115315-98AA-1F84-30F5-F9FDB9B87A23}"/>
              </a:ext>
            </a:extLst>
          </p:cNvPr>
          <p:cNvSpPr txBox="1"/>
          <p:nvPr/>
        </p:nvSpPr>
        <p:spPr>
          <a:xfrm>
            <a:off x="90236" y="97239"/>
            <a:ext cx="11764880" cy="12167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6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5 :  Gating strategy for Tregs</a:t>
            </a:r>
            <a:endParaRPr lang="en-IN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buNone/>
            </a:pPr>
            <a:r>
              <a:rPr lang="en-IN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) FSC-H vs. FSC-A plot was used to remove doublets and cell debris. (B)  Forward scatter (FSC) versus side scatter (SSC) plot demonstrates gating of pan-lymphocytes. (C) SSC versus CD3 plot is utilized to gate T cells within the lymphocyte population.(D) CD3 versus CD4 plot on T cells is employed for the identification of T helper (Th) cells. (E) Within Th cells, gating of CD25high and CD127low </a:t>
            </a:r>
            <a:endParaRPr lang="en-US" sz="1600" dirty="0"/>
          </a:p>
        </p:txBody>
      </p:sp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159B3C57-1F3F-4FA6-60A2-4B1D76FF7A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722" y="2233411"/>
            <a:ext cx="11908556" cy="2586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23879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C3B9D11-6286-C215-5C73-C558625E6BD8}"/>
              </a:ext>
            </a:extLst>
          </p:cNvPr>
          <p:cNvSpPr txBox="1"/>
          <p:nvPr/>
        </p:nvSpPr>
        <p:spPr>
          <a:xfrm>
            <a:off x="186489" y="122115"/>
            <a:ext cx="11857121" cy="23878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6 :  Gating strategy for CTLA4 protein expression by flow cytometry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) Forward scatter (FSC) versus side scatter (SSC) plot demonstrates gating of pan-lymphocytes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) SSC versus CD3 plot is utilized to gate T cells within the lymphocyte population.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IN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) CD3 versus CD4 plot on T cells is employed for the identification of T helper (Th) cells. d) Within Th cells, gating of CD25high and CD127low populations is utilized to identify regulatory T (Treg) cells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buNone/>
            </a:pPr>
            <a:r>
              <a:rPr lang="en-IN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e) Red peak represents Patient  stimulated expression (C2), Green peak represents healthy control stimulated condition , and Blue peak indicates the unstimulated condition of the patient. The expression of CTLA4 is compared to the healthy control. In this instance, C2 shows an expression of 12% on the CD4+CD25high and CD127low population, whereas the healthy control demonstrates approximately 90% expression.</a:t>
            </a:r>
            <a:r>
              <a:rPr lang="en-IN" sz="1400" dirty="0">
                <a:effectLst/>
              </a:rPr>
              <a:t> </a:t>
            </a:r>
            <a:endParaRPr lang="en-US" sz="1400" dirty="0"/>
          </a:p>
        </p:txBody>
      </p:sp>
      <p:pic>
        <p:nvPicPr>
          <p:cNvPr id="5" name="Picture 4" descr="A close-up of a graph&#10;&#10;AI-generated content may be incorrect.">
            <a:extLst>
              <a:ext uri="{FF2B5EF4-FFF2-40B4-BE49-F238E27FC236}">
                <a16:creationId xmlns:a16="http://schemas.microsoft.com/office/drawing/2014/main" id="{B67C511B-BF03-9FDF-975F-8CA5F7995C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2482" y="2509948"/>
            <a:ext cx="7306844" cy="4011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76786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7FAD897-1B78-2DC2-5368-0B320A66CA7D}"/>
              </a:ext>
            </a:extLst>
          </p:cNvPr>
          <p:cNvSpPr txBox="1"/>
          <p:nvPr/>
        </p:nvSpPr>
        <p:spPr>
          <a:xfrm>
            <a:off x="294772" y="1"/>
            <a:ext cx="11897227" cy="2286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b="1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S7 : Gating strategy for LRBA protein expression by flow cytometry. 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) Side scatter (SSC) versus CD45 plot was utilized to gate lymphocytes.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) SSC versus CD3 plot is employed to gate T cells.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) Following stimulation, activated T cells are identified using the CD69 marker.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) LRBA expression was evaluated on the CD69  and CD3 co-positive population. The green peak represents LRBA protein expression on healthy control after stimulation (71%), the red peak indicates LRBA deficient patient with an expression of 12%, and the blue peak indicates LRBA expression in L2 at an unstimulated condition (CD3+ only).</a:t>
            </a:r>
            <a:endParaRPr lang="en-IN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diagram of a diagram of a number of blue dots&#10;&#10;AI-generated content may be incorrect.">
            <a:extLst>
              <a:ext uri="{FF2B5EF4-FFF2-40B4-BE49-F238E27FC236}">
                <a16:creationId xmlns:a16="http://schemas.microsoft.com/office/drawing/2014/main" id="{FF44E288-2B91-5159-67EE-27602AD7DC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045" y="3140244"/>
            <a:ext cx="10821909" cy="3080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6063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018</Words>
  <Application>Microsoft Macintosh PowerPoint</Application>
  <PresentationFormat>Widescreen</PresentationFormat>
  <Paragraphs>1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RIYANKA SETIA</dc:creator>
  <cp:lastModifiedBy>PRIYANKA SETIA</cp:lastModifiedBy>
  <cp:revision>1</cp:revision>
  <dcterms:created xsi:type="dcterms:W3CDTF">2025-08-18T05:22:07Z</dcterms:created>
  <dcterms:modified xsi:type="dcterms:W3CDTF">2025-08-18T05:34:13Z</dcterms:modified>
</cp:coreProperties>
</file>